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2" d="100"/>
          <a:sy n="82" d="100"/>
        </p:scale>
        <p:origin x="126" y="10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805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043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690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169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954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332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590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807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740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883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817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7CCFE-29D0-4A03-8689-5BE070769A87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DA23AC-22DA-4E87-B549-4EB122221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489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92FDB4A-39D3-46D3-BDA8-FEE7F8ECF2BC}"/>
              </a:ext>
            </a:extLst>
          </p:cNvPr>
          <p:cNvSpPr txBox="1"/>
          <p:nvPr/>
        </p:nvSpPr>
        <p:spPr>
          <a:xfrm>
            <a:off x="2332892" y="5251939"/>
            <a:ext cx="7054293" cy="9706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450"/>
              </a:spcAft>
              <a:tabLst>
                <a:tab pos="3343191" algn="r"/>
              </a:tabLst>
            </a:pPr>
            <a:r>
              <a:rPr lang="en-US" sz="135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ony forming unit (CFU) in spleens of C57BL/6 mice vaccinated SC with a dose of ~ 1 x 10</a:t>
            </a:r>
            <a:r>
              <a:rPr lang="en-US" sz="135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FU of 668 </a:t>
            </a:r>
            <a:r>
              <a:rPr lang="en-US" sz="135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∆</a:t>
            </a:r>
            <a:r>
              <a:rPr lang="en-US" sz="135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vI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 Five mice were euthanized on days 1, 2, 3, 4, 7, 10, and 15 post-vaccination.  The CFU were enumerated on diluted spleen homogenates plated on SBA.  The individual dots each represent one mouse and the horizontal bars are the median values.</a:t>
            </a:r>
            <a:endParaRPr lang="en-US" sz="135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A close up of a logo&#10;&#10;Description automatically generated">
            <a:extLst>
              <a:ext uri="{FF2B5EF4-FFF2-40B4-BE49-F238E27FC236}">
                <a16:creationId xmlns:a16="http://schemas.microsoft.com/office/drawing/2014/main" id="{E5590664-7E48-45A0-9DB0-4EC7B6EBC3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4815" y="154438"/>
            <a:ext cx="5542016" cy="5097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30553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043DBC4-D3A0-4AE7-A838-84C29AC360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06428" y="0"/>
            <a:ext cx="2379143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BAAB566-6B02-4718-8F07-0314AEC374EC}"/>
              </a:ext>
            </a:extLst>
          </p:cNvPr>
          <p:cNvSpPr txBox="1"/>
          <p:nvPr/>
        </p:nvSpPr>
        <p:spPr>
          <a:xfrm>
            <a:off x="505123" y="2093332"/>
            <a:ext cx="390275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able S6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Fold change relative to Adjuvant group of spleen homogenates from vaccinated mice challenged with</a:t>
            </a:r>
            <a:r>
              <a:rPr lang="en-US" sz="1800" b="0" i="1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B. mallei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FMH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392675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2651139-253A-4D0C-B741-0DCBF9B2FD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2817" y="0"/>
            <a:ext cx="2346365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67311B6-EBA4-4C18-8972-CA3B8D31FF85}"/>
              </a:ext>
            </a:extLst>
          </p:cNvPr>
          <p:cNvSpPr txBox="1"/>
          <p:nvPr/>
        </p:nvSpPr>
        <p:spPr>
          <a:xfrm>
            <a:off x="880261" y="1706470"/>
            <a:ext cx="364484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Table S7.  Fold change relative to Adjuvant group of spleen homogenates from vaccinated mice challenged with </a:t>
            </a:r>
            <a:r>
              <a:rPr lang="en-US" i="1" dirty="0"/>
              <a:t>Bp</a:t>
            </a:r>
            <a:r>
              <a:rPr lang="en-US" dirty="0"/>
              <a:t> MSHR5855 </a:t>
            </a:r>
          </a:p>
        </p:txBody>
      </p:sp>
    </p:spTree>
    <p:extLst>
      <p:ext uri="{BB962C8B-B14F-4D97-AF65-F5344CB8AC3E}">
        <p14:creationId xmlns:p14="http://schemas.microsoft.com/office/powerpoint/2010/main" val="643435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0B77EDD-030C-4141-8CC8-F0BF69895B4E}"/>
              </a:ext>
            </a:extLst>
          </p:cNvPr>
          <p:cNvSpPr txBox="1"/>
          <p:nvPr/>
        </p:nvSpPr>
        <p:spPr>
          <a:xfrm>
            <a:off x="2919046" y="5594842"/>
            <a:ext cx="6928338" cy="9706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450"/>
              </a:spcAft>
              <a:tabLst>
                <a:tab pos="3343191" algn="r"/>
              </a:tabLst>
            </a:pPr>
            <a:r>
              <a:rPr lang="en-US" sz="135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urvival analysis of mice challenged with </a:t>
            </a:r>
            <a:r>
              <a:rPr lang="en-US" sz="135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9624 by the aerosol route.  Each symbol represents the time to morbidity (TTM, day) after challenge of each mouse. The greyed-out symbols indicate survivors at day 60 post-challenge.  The solid triangle for each group is the mean number of survival days among the mice that succumbed to infection.</a:t>
            </a:r>
            <a:endParaRPr lang="en-US" sz="135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screenshot of a social media post&#10;&#10;Description automatically generated">
            <a:extLst>
              <a:ext uri="{FF2B5EF4-FFF2-40B4-BE49-F238E27FC236}">
                <a16:creationId xmlns:a16="http://schemas.microsoft.com/office/drawing/2014/main" id="{B687FC22-C88C-4062-93A5-B0438F0D40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4616" y="126024"/>
            <a:ext cx="7291754" cy="54688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13737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6BA60EF-F567-4311-9817-946176C3970B}"/>
              </a:ext>
            </a:extLst>
          </p:cNvPr>
          <p:cNvSpPr txBox="1"/>
          <p:nvPr/>
        </p:nvSpPr>
        <p:spPr>
          <a:xfrm>
            <a:off x="2215662" y="5947006"/>
            <a:ext cx="8181115" cy="5260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450"/>
              </a:spcAft>
              <a:tabLst>
                <a:tab pos="3343191" algn="r"/>
              </a:tabLst>
            </a:pPr>
            <a:r>
              <a:rPr lang="en-US" sz="135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kine analysis of spleen homogenates from vaccinated mice collected three days after challenge with a 3.4 LD</a:t>
            </a:r>
            <a:r>
              <a:rPr lang="en-US" sz="135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ose of </a:t>
            </a:r>
            <a:r>
              <a:rPr lang="en-US" sz="135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96243.  Cytokine levels are indicated as </a:t>
            </a:r>
            <a:r>
              <a:rPr lang="en-US" sz="135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g</a:t>
            </a:r>
            <a:r>
              <a:rPr lang="en-US" sz="135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ml homogenate supernatant.  </a:t>
            </a:r>
            <a:endParaRPr lang="en-US" sz="135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A screenshot of a computer&#10;&#10;Description automatically generated">
            <a:extLst>
              <a:ext uri="{FF2B5EF4-FFF2-40B4-BE49-F238E27FC236}">
                <a16:creationId xmlns:a16="http://schemas.microsoft.com/office/drawing/2014/main" id="{E005EB37-F93E-4D1A-BF48-DE1952CE02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2708" y="244709"/>
            <a:ext cx="10843846" cy="5527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9863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578471E-1086-4765-92BF-0F83FBB0D786}"/>
              </a:ext>
            </a:extLst>
          </p:cNvPr>
          <p:cNvSpPr txBox="1"/>
          <p:nvPr/>
        </p:nvSpPr>
        <p:spPr>
          <a:xfrm>
            <a:off x="1125415" y="5424318"/>
            <a:ext cx="9941169" cy="7483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indent="45720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tabLst>
                <a:tab pos="5943600" algn="r"/>
              </a:tabLst>
            </a:pPr>
            <a:r>
              <a:rPr lang="en-US" sz="135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 </a:t>
            </a:r>
            <a:r>
              <a:rPr lang="en-US" sz="135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rvival analysis (TTM) of mice challenged with </a:t>
            </a:r>
            <a:r>
              <a:rPr lang="en-US" sz="13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n-US" sz="135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SHR5855 or </a:t>
            </a:r>
            <a:r>
              <a:rPr lang="en-US" sz="13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m</a:t>
            </a:r>
            <a:r>
              <a:rPr lang="en-US" sz="135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MH by the aerosol route. The results of the two exposure experiments with </a:t>
            </a:r>
            <a:r>
              <a:rPr lang="en-US" sz="13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m</a:t>
            </a:r>
            <a:r>
              <a:rPr lang="en-US" sz="135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MH (</a:t>
            </a:r>
            <a:r>
              <a:rPr lang="en-US" sz="135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35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with </a:t>
            </a:r>
            <a:r>
              <a:rPr lang="en-US" sz="135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n-US" sz="135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SHR5855 (</a:t>
            </a:r>
            <a:r>
              <a:rPr lang="en-US" sz="135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35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n= 20 mice/group.  Each symbol represents the time to morbidity (day) after challenge of each mouse.  The greyed-out symbols indicate survivors at day 60 post-challenge.</a:t>
            </a:r>
            <a:endParaRPr lang="en-US" sz="135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A picture containing map&#10;&#10;Description automatically generated">
            <a:extLst>
              <a:ext uri="{FF2B5EF4-FFF2-40B4-BE49-F238E27FC236}">
                <a16:creationId xmlns:a16="http://schemas.microsoft.com/office/drawing/2014/main" id="{378D5CE6-FE76-47A8-8B62-B76127994F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579" y="228136"/>
            <a:ext cx="5156886" cy="5156886"/>
          </a:xfrm>
          <a:prstGeom prst="rect">
            <a:avLst/>
          </a:prstGeom>
        </p:spPr>
      </p:pic>
      <p:pic>
        <p:nvPicPr>
          <p:cNvPr id="9" name="Picture 8" descr="A close up of a mans face&#10;&#10;Description automatically generated">
            <a:extLst>
              <a:ext uri="{FF2B5EF4-FFF2-40B4-BE49-F238E27FC236}">
                <a16:creationId xmlns:a16="http://schemas.microsoft.com/office/drawing/2014/main" id="{349377DC-A1B4-471E-AC95-9D895BD7F87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6043" y="228136"/>
            <a:ext cx="5156886" cy="515688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575CFED-2F7F-476B-BCEF-6FF42E840014}"/>
              </a:ext>
            </a:extLst>
          </p:cNvPr>
          <p:cNvSpPr txBox="1"/>
          <p:nvPr/>
        </p:nvSpPr>
        <p:spPr>
          <a:xfrm>
            <a:off x="172995" y="228136"/>
            <a:ext cx="626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C2093CA-DC72-4795-AF81-130D597B1963}"/>
              </a:ext>
            </a:extLst>
          </p:cNvPr>
          <p:cNvSpPr txBox="1"/>
          <p:nvPr/>
        </p:nvSpPr>
        <p:spPr>
          <a:xfrm>
            <a:off x="6182499" y="195870"/>
            <a:ext cx="626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256166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F0D33C3-5B38-4E94-93DF-4859526DA4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6006" y="0"/>
            <a:ext cx="8512233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0C8E16B-0F96-48EE-B48F-C52F14EDB9A7}"/>
              </a:ext>
            </a:extLst>
          </p:cNvPr>
          <p:cNvSpPr txBox="1"/>
          <p:nvPr/>
        </p:nvSpPr>
        <p:spPr>
          <a:xfrm>
            <a:off x="187568" y="897578"/>
            <a:ext cx="2274278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able S1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 The fold change relative to the PBS group in cytokine responses of splenocytes obtained pre-challenge (day 65) and stimulated with Hcp1 or </a:t>
            </a:r>
            <a:r>
              <a:rPr lang="en-US" sz="18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hpC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antigen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2015365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64050B5-469C-4ECB-8467-9E860150AB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2758" y="111211"/>
            <a:ext cx="9410700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F311B23-33E6-4F13-BAA7-265DD427B8F6}"/>
              </a:ext>
            </a:extLst>
          </p:cNvPr>
          <p:cNvSpPr txBox="1"/>
          <p:nvPr/>
        </p:nvSpPr>
        <p:spPr>
          <a:xfrm>
            <a:off x="376168" y="1792058"/>
            <a:ext cx="212659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able S2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Fold change relative to PBS group of lung and spleen homogenates from vaccinated mice (Day 65)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4147180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FC2B03A-CCB9-42AA-BEC6-2B2DDC7956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3191" y="0"/>
            <a:ext cx="4085617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5C264CC-C366-49B6-9105-39FF7FE68884}"/>
              </a:ext>
            </a:extLst>
          </p:cNvPr>
          <p:cNvSpPr txBox="1"/>
          <p:nvPr/>
        </p:nvSpPr>
        <p:spPr>
          <a:xfrm>
            <a:off x="200323" y="2146720"/>
            <a:ext cx="366829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able S3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The fold change in cytokine levels relative to PBS of spleen homogenates from mice three days post-challenge (day 79) with </a:t>
            </a:r>
            <a:r>
              <a:rPr lang="en-US" sz="1800" b="0" i="1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p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K96243.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1068055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EB6C8C6-A3B5-49BD-AFEA-A07DF3DA44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7666" y="1"/>
            <a:ext cx="5716668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A720832-CE0D-4500-85A4-A796A5BE481D}"/>
              </a:ext>
            </a:extLst>
          </p:cNvPr>
          <p:cNvSpPr txBox="1"/>
          <p:nvPr/>
        </p:nvSpPr>
        <p:spPr>
          <a:xfrm>
            <a:off x="188637" y="2261442"/>
            <a:ext cx="3492409" cy="12631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tabLst>
                <a:tab pos="5943600" algn="r"/>
              </a:tabLs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4. Fold change in cytokine levels of post-challenge (day 79) spleen homogenates relative to    day 65 pre-challenge levels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10131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E9C9B7C-B2CF-41B4-9A87-D26746483B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0351" y="1540683"/>
            <a:ext cx="9268361" cy="337128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378C17A-323C-4E43-8107-8E959818D4A1}"/>
              </a:ext>
            </a:extLst>
          </p:cNvPr>
          <p:cNvSpPr txBox="1"/>
          <p:nvPr/>
        </p:nvSpPr>
        <p:spPr>
          <a:xfrm>
            <a:off x="2298238" y="1015680"/>
            <a:ext cx="75955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able S5. Detection of bacteria in mice surviving challenge with </a:t>
            </a:r>
            <a:r>
              <a:rPr lang="en-US" sz="1800" b="0" i="1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. mallei 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FMH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846836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415</Words>
  <Application>Microsoft Office PowerPoint</Application>
  <PresentationFormat>Widescreen</PresentationFormat>
  <Paragraphs>13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fense Health Agenc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te, Christopher K CIV USARMY USAMRIID (USA)</dc:creator>
  <cp:lastModifiedBy>Cote, Christopher K CIV USARMY USAMRIID (USA)</cp:lastModifiedBy>
  <cp:revision>5</cp:revision>
  <dcterms:created xsi:type="dcterms:W3CDTF">2022-08-03T13:09:33Z</dcterms:created>
  <dcterms:modified xsi:type="dcterms:W3CDTF">2022-08-03T14:14:39Z</dcterms:modified>
</cp:coreProperties>
</file>